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1" autoAdjust="0"/>
    <p:restoredTop sz="94660"/>
  </p:normalViewPr>
  <p:slideViewPr>
    <p:cSldViewPr snapToGrid="0">
      <p:cViewPr varScale="1">
        <p:scale>
          <a:sx n="141" d="100"/>
          <a:sy n="141" d="100"/>
        </p:scale>
        <p:origin x="16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815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834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076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209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935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328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747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099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689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645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69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3A0AF-D6EF-476B-8C09-028DA4A0CB9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5AFE21-1B14-4FA6-B36D-C19A4AA5AE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000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A8F356E-94AD-4694-A723-91AFF2B4C24C}"/>
              </a:ext>
            </a:extLst>
          </p:cNvPr>
          <p:cNvGrpSpPr/>
          <p:nvPr/>
        </p:nvGrpSpPr>
        <p:grpSpPr>
          <a:xfrm>
            <a:off x="289711" y="457199"/>
            <a:ext cx="8564578" cy="4793811"/>
            <a:chOff x="977660" y="1828800"/>
            <a:chExt cx="6927047" cy="3566160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1DD3BD80-0AF7-4572-AF2E-775B7BE65F0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977660" y="1828800"/>
              <a:ext cx="3463523" cy="3566160"/>
              <a:chOff x="3082685" y="228600"/>
              <a:chExt cx="3108291" cy="3200400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93FE3E02-BF8E-4594-B5A5-4ACBEAE0F90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296998" y="228600"/>
                <a:ext cx="2893978" cy="3200400"/>
                <a:chOff x="1125300" y="676200"/>
                <a:chExt cx="2550000" cy="282000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57E94CB6-11BF-4883-A389-152CAA3200B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25300" y="6762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68BEEE89-7BF7-473D-B1D3-B16ABF3311E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25300" y="13812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60F2F304-F43B-4F8E-8633-ABCD4DB995C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25300" y="20862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BD24DF2F-9091-4072-8DF5-00ADE8E6A15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25300" y="2791200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591F8508-ECC2-4391-8496-7CE7363F44DF}"/>
                  </a:ext>
                </a:extLst>
              </p:cNvPr>
              <p:cNvSpPr txBox="1"/>
              <p:nvPr/>
            </p:nvSpPr>
            <p:spPr>
              <a:xfrm>
                <a:off x="3082685" y="228600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46371233-E33C-4ECC-B8AC-A4B249241E6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441183" y="1828800"/>
              <a:ext cx="3463524" cy="3566160"/>
              <a:chOff x="3082684" y="3505351"/>
              <a:chExt cx="3108292" cy="3200400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7A9B9060-83B1-42C8-83E0-9506A420FF5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296998" y="3505351"/>
                <a:ext cx="2893978" cy="3200400"/>
                <a:chOff x="4982925" y="676200"/>
                <a:chExt cx="2550000" cy="2820000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BBAB4867-ED8A-4E8B-AD6F-17E6888DDE9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82925" y="6762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1E1ED407-D18F-4E44-8E11-54A8A79CE0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82925" y="13812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5F8A11BA-22E7-4AC6-B491-CA816498D4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82925" y="20862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id="{4710FD23-9D9B-4F69-9FEA-57A206FBFB1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982925" y="2791200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1F250BCF-E630-4EBC-AA63-AB0AA5931DC8}"/>
                  </a:ext>
                </a:extLst>
              </p:cNvPr>
              <p:cNvSpPr txBox="1"/>
              <p:nvPr/>
            </p:nvSpPr>
            <p:spPr>
              <a:xfrm>
                <a:off x="3082684" y="3505351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17C0DD02-3851-4C75-A069-543015C69B4F}"/>
              </a:ext>
            </a:extLst>
          </p:cNvPr>
          <p:cNvSpPr txBox="1"/>
          <p:nvPr/>
        </p:nvSpPr>
        <p:spPr>
          <a:xfrm>
            <a:off x="850337" y="5596593"/>
            <a:ext cx="74433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6 Fig. PpSP44 nucleotide and amino acid varia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nucleotide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amino acid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</a:t>
            </a:r>
          </a:p>
        </p:txBody>
      </p:sp>
    </p:spTree>
    <p:extLst>
      <p:ext uri="{BB962C8B-B14F-4D97-AF65-F5344CB8AC3E}">
        <p14:creationId xmlns:p14="http://schemas.microsoft.com/office/powerpoint/2010/main" val="1637826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e Flanley</dc:creator>
  <cp:lastModifiedBy>Cate Flanley</cp:lastModifiedBy>
  <cp:revision>2</cp:revision>
  <dcterms:created xsi:type="dcterms:W3CDTF">2019-01-18T03:19:34Z</dcterms:created>
  <dcterms:modified xsi:type="dcterms:W3CDTF">2020-06-21T17:56:32Z</dcterms:modified>
</cp:coreProperties>
</file>